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ofa\shared$\Science\AgFood&amp;Wine\research\cereal%20grain%20biochemistry\Adinda\Publications\CPS%207B%202020\LMA%207B%20MS%20Adinda%20Feb%202020\All%20expt%20with%204%20ctl%20genes%20normalised%20by%20Elen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xpt3_3GNF!$S$266</c:f>
              <c:strCache>
                <c:ptCount val="1"/>
                <c:pt idx="0">
                  <c:v>10 DP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Y$280:$Z$280</c:f>
                <c:numCache>
                  <c:formatCode>General</c:formatCode>
                  <c:ptCount val="2"/>
                  <c:pt idx="0">
                    <c:v>1420.1290682987585</c:v>
                  </c:pt>
                  <c:pt idx="1">
                    <c:v>1032.8857873323195</c:v>
                  </c:pt>
                </c:numCache>
              </c:numRef>
            </c:plus>
            <c:minus>
              <c:numRef>
                <c:f>Expt3_3GNF!$T$280:$Z$280</c:f>
                <c:numCache>
                  <c:formatCode>General</c:formatCode>
                  <c:ptCount val="7"/>
                  <c:pt idx="0">
                    <c:v>1433.9416665360372</c:v>
                  </c:pt>
                  <c:pt idx="1">
                    <c:v>415.42876907314093</c:v>
                  </c:pt>
                  <c:pt idx="2">
                    <c:v>5104.0593284753777</c:v>
                  </c:pt>
                  <c:pt idx="3">
                    <c:v>1617.1628983541045</c:v>
                  </c:pt>
                  <c:pt idx="4">
                    <c:v>745.79486808377089</c:v>
                  </c:pt>
                  <c:pt idx="5">
                    <c:v>1420.1290682987585</c:v>
                  </c:pt>
                  <c:pt idx="6">
                    <c:v>1032.88578733231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66:$Z$266</c:f>
              <c:numCache>
                <c:formatCode>General</c:formatCode>
                <c:ptCount val="7"/>
                <c:pt idx="0">
                  <c:v>6170.9249969708544</c:v>
                </c:pt>
                <c:pt idx="1">
                  <c:v>14192.410356478162</c:v>
                </c:pt>
                <c:pt idx="2">
                  <c:v>12777.067122933871</c:v>
                </c:pt>
                <c:pt idx="3">
                  <c:v>4221.2026378558476</c:v>
                </c:pt>
                <c:pt idx="4">
                  <c:v>3457.1346598204432</c:v>
                </c:pt>
                <c:pt idx="5">
                  <c:v>3824.8272469293884</c:v>
                </c:pt>
                <c:pt idx="6">
                  <c:v>4027.59408430341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F2-4E34-A7FC-9683FAC0C143}"/>
            </c:ext>
          </c:extLst>
        </c:ser>
        <c:ser>
          <c:idx val="1"/>
          <c:order val="1"/>
          <c:tx>
            <c:strRef>
              <c:f>Expt3_3GNF!$S$267</c:f>
              <c:strCache>
                <c:ptCount val="1"/>
                <c:pt idx="0">
                  <c:v>15 DP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1:$Z$281</c:f>
                <c:numCache>
                  <c:formatCode>General</c:formatCode>
                  <c:ptCount val="7"/>
                  <c:pt idx="0">
                    <c:v>21308.511823519508</c:v>
                  </c:pt>
                  <c:pt idx="1">
                    <c:v>10621.004208420709</c:v>
                  </c:pt>
                  <c:pt idx="2">
                    <c:v>5255.2729062883718</c:v>
                  </c:pt>
                  <c:pt idx="3">
                    <c:v>2713.761964710337</c:v>
                  </c:pt>
                  <c:pt idx="4">
                    <c:v>3209.7747894810941</c:v>
                  </c:pt>
                  <c:pt idx="5">
                    <c:v>1513.5762563031992</c:v>
                  </c:pt>
                  <c:pt idx="6">
                    <c:v>340.34193510264288</c:v>
                  </c:pt>
                </c:numCache>
              </c:numRef>
            </c:plus>
            <c:minus>
              <c:numRef>
                <c:f>Expt3_3GNF!$T$281:$Z$281</c:f>
                <c:numCache>
                  <c:formatCode>General</c:formatCode>
                  <c:ptCount val="7"/>
                  <c:pt idx="0">
                    <c:v>21308.511823519508</c:v>
                  </c:pt>
                  <c:pt idx="1">
                    <c:v>10621.004208420709</c:v>
                  </c:pt>
                  <c:pt idx="2">
                    <c:v>5255.2729062883718</c:v>
                  </c:pt>
                  <c:pt idx="3">
                    <c:v>2713.761964710337</c:v>
                  </c:pt>
                  <c:pt idx="4">
                    <c:v>3209.7747894810941</c:v>
                  </c:pt>
                  <c:pt idx="5">
                    <c:v>1513.5762563031992</c:v>
                  </c:pt>
                  <c:pt idx="6">
                    <c:v>340.341935102642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67:$Z$267</c:f>
              <c:numCache>
                <c:formatCode>General</c:formatCode>
                <c:ptCount val="7"/>
                <c:pt idx="0">
                  <c:v>115222.71759808953</c:v>
                </c:pt>
                <c:pt idx="1">
                  <c:v>97081.382997926601</c:v>
                </c:pt>
                <c:pt idx="2">
                  <c:v>63587.278244696965</c:v>
                </c:pt>
                <c:pt idx="3">
                  <c:v>13697.272103470677</c:v>
                </c:pt>
                <c:pt idx="4">
                  <c:v>10191.065653772299</c:v>
                </c:pt>
                <c:pt idx="5">
                  <c:v>11635.64547425166</c:v>
                </c:pt>
                <c:pt idx="6">
                  <c:v>5824.8221435408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F2-4E34-A7FC-9683FAC0C143}"/>
            </c:ext>
          </c:extLst>
        </c:ser>
        <c:ser>
          <c:idx val="2"/>
          <c:order val="2"/>
          <c:tx>
            <c:strRef>
              <c:f>Expt3_3GNF!$S$268</c:f>
              <c:strCache>
                <c:ptCount val="1"/>
                <c:pt idx="0">
                  <c:v>18 DP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2:$Z$282</c:f>
                <c:numCache>
                  <c:formatCode>General</c:formatCode>
                  <c:ptCount val="7"/>
                  <c:pt idx="0">
                    <c:v>5962.2174056031299</c:v>
                  </c:pt>
                  <c:pt idx="1">
                    <c:v>7284.0908612205249</c:v>
                  </c:pt>
                  <c:pt idx="2">
                    <c:v>6824.3924135218349</c:v>
                  </c:pt>
                  <c:pt idx="3">
                    <c:v>4795.6202862234031</c:v>
                  </c:pt>
                  <c:pt idx="4">
                    <c:v>1950.0275180868746</c:v>
                  </c:pt>
                  <c:pt idx="5">
                    <c:v>2166.2626854250739</c:v>
                  </c:pt>
                  <c:pt idx="6">
                    <c:v>3028.3578966913947</c:v>
                  </c:pt>
                </c:numCache>
              </c:numRef>
            </c:plus>
            <c:minus>
              <c:numRef>
                <c:f>Expt3_3GNF!$T$282:$Z$282</c:f>
                <c:numCache>
                  <c:formatCode>General</c:formatCode>
                  <c:ptCount val="7"/>
                  <c:pt idx="0">
                    <c:v>5962.2174056031299</c:v>
                  </c:pt>
                  <c:pt idx="1">
                    <c:v>7284.0908612205249</c:v>
                  </c:pt>
                  <c:pt idx="2">
                    <c:v>6824.3924135218349</c:v>
                  </c:pt>
                  <c:pt idx="3">
                    <c:v>4795.6202862234031</c:v>
                  </c:pt>
                  <c:pt idx="4">
                    <c:v>1950.0275180868746</c:v>
                  </c:pt>
                  <c:pt idx="5">
                    <c:v>2166.2626854250739</c:v>
                  </c:pt>
                  <c:pt idx="6">
                    <c:v>3028.35789669139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68:$Z$268</c:f>
              <c:numCache>
                <c:formatCode>General</c:formatCode>
                <c:ptCount val="7"/>
                <c:pt idx="0">
                  <c:v>50473.405968393527</c:v>
                </c:pt>
                <c:pt idx="1">
                  <c:v>56699.319973265578</c:v>
                </c:pt>
                <c:pt idx="2">
                  <c:v>67311.163401549333</c:v>
                </c:pt>
                <c:pt idx="3">
                  <c:v>23940.579420431739</c:v>
                </c:pt>
                <c:pt idx="4">
                  <c:v>17262.328909572934</c:v>
                </c:pt>
                <c:pt idx="5">
                  <c:v>8766.0424632248596</c:v>
                </c:pt>
                <c:pt idx="6">
                  <c:v>8917.9366768391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F2-4E34-A7FC-9683FAC0C143}"/>
            </c:ext>
          </c:extLst>
        </c:ser>
        <c:ser>
          <c:idx val="3"/>
          <c:order val="3"/>
          <c:tx>
            <c:strRef>
              <c:f>Expt3_3GNF!$S$269</c:f>
              <c:strCache>
                <c:ptCount val="1"/>
                <c:pt idx="0">
                  <c:v>21 DP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3:$Z$283</c:f>
                <c:numCache>
                  <c:formatCode>General</c:formatCode>
                  <c:ptCount val="7"/>
                  <c:pt idx="0">
                    <c:v>11560.945632061801</c:v>
                  </c:pt>
                  <c:pt idx="1">
                    <c:v>11528.308361876143</c:v>
                  </c:pt>
                  <c:pt idx="2">
                    <c:v>2033.5647261159286</c:v>
                  </c:pt>
                  <c:pt idx="3">
                    <c:v>3201.014413139982</c:v>
                  </c:pt>
                  <c:pt idx="4">
                    <c:v>4341.7872528170992</c:v>
                  </c:pt>
                  <c:pt idx="5">
                    <c:v>818.68056913417479</c:v>
                  </c:pt>
                  <c:pt idx="6">
                    <c:v>1609.7624459010085</c:v>
                  </c:pt>
                </c:numCache>
              </c:numRef>
            </c:plus>
            <c:minus>
              <c:numRef>
                <c:f>Expt3_3GNF!$T$283:$Z$283</c:f>
                <c:numCache>
                  <c:formatCode>General</c:formatCode>
                  <c:ptCount val="7"/>
                  <c:pt idx="0">
                    <c:v>11560.945632061801</c:v>
                  </c:pt>
                  <c:pt idx="1">
                    <c:v>11528.308361876143</c:v>
                  </c:pt>
                  <c:pt idx="2">
                    <c:v>2033.5647261159286</c:v>
                  </c:pt>
                  <c:pt idx="3">
                    <c:v>3201.014413139982</c:v>
                  </c:pt>
                  <c:pt idx="4">
                    <c:v>4341.7872528170992</c:v>
                  </c:pt>
                  <c:pt idx="5">
                    <c:v>818.68056913417479</c:v>
                  </c:pt>
                  <c:pt idx="6">
                    <c:v>1609.76244590100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69:$Z$269</c:f>
              <c:numCache>
                <c:formatCode>General</c:formatCode>
                <c:ptCount val="7"/>
                <c:pt idx="0">
                  <c:v>69006.029943567788</c:v>
                </c:pt>
                <c:pt idx="1">
                  <c:v>51142.679972872429</c:v>
                </c:pt>
                <c:pt idx="2">
                  <c:v>8545.3230005908517</c:v>
                </c:pt>
                <c:pt idx="3">
                  <c:v>19449.196571410539</c:v>
                </c:pt>
                <c:pt idx="4">
                  <c:v>22971.2791076635</c:v>
                </c:pt>
                <c:pt idx="5">
                  <c:v>3428.9050461931329</c:v>
                </c:pt>
                <c:pt idx="6">
                  <c:v>5280.0256527823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DF2-4E34-A7FC-9683FAC0C143}"/>
            </c:ext>
          </c:extLst>
        </c:ser>
        <c:ser>
          <c:idx val="4"/>
          <c:order val="4"/>
          <c:tx>
            <c:strRef>
              <c:f>Expt3_3GNF!$S$270</c:f>
              <c:strCache>
                <c:ptCount val="1"/>
                <c:pt idx="0">
                  <c:v>24 DP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4:$Z$284</c:f>
                <c:numCache>
                  <c:formatCode>General</c:formatCode>
                  <c:ptCount val="7"/>
                  <c:pt idx="0">
                    <c:v>1209.7954502102793</c:v>
                  </c:pt>
                  <c:pt idx="1">
                    <c:v>3896.075631467997</c:v>
                  </c:pt>
                  <c:pt idx="2">
                    <c:v>713.23315069522698</c:v>
                  </c:pt>
                  <c:pt idx="3">
                    <c:v>1518.7139409736194</c:v>
                  </c:pt>
                  <c:pt idx="4">
                    <c:v>1453.3745295327799</c:v>
                  </c:pt>
                  <c:pt idx="5">
                    <c:v>1582.053262759481</c:v>
                  </c:pt>
                  <c:pt idx="6">
                    <c:v>3037.6272939772389</c:v>
                  </c:pt>
                </c:numCache>
              </c:numRef>
            </c:plus>
            <c:minus>
              <c:numRef>
                <c:f>Expt3_3GNF!$T$284:$Z$284</c:f>
                <c:numCache>
                  <c:formatCode>General</c:formatCode>
                  <c:ptCount val="7"/>
                  <c:pt idx="0">
                    <c:v>1209.7954502102793</c:v>
                  </c:pt>
                  <c:pt idx="1">
                    <c:v>3896.075631467997</c:v>
                  </c:pt>
                  <c:pt idx="2">
                    <c:v>713.23315069522698</c:v>
                  </c:pt>
                  <c:pt idx="3">
                    <c:v>1518.7139409736194</c:v>
                  </c:pt>
                  <c:pt idx="4">
                    <c:v>1453.3745295327799</c:v>
                  </c:pt>
                  <c:pt idx="5">
                    <c:v>1582.053262759481</c:v>
                  </c:pt>
                  <c:pt idx="6">
                    <c:v>3037.62729397723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0:$Z$270</c:f>
              <c:numCache>
                <c:formatCode>General</c:formatCode>
                <c:ptCount val="7"/>
                <c:pt idx="0">
                  <c:v>5615.6140166350269</c:v>
                </c:pt>
                <c:pt idx="1">
                  <c:v>21056.459922526861</c:v>
                </c:pt>
                <c:pt idx="2">
                  <c:v>8907.9293973457279</c:v>
                </c:pt>
                <c:pt idx="3">
                  <c:v>10924.014633625398</c:v>
                </c:pt>
                <c:pt idx="4">
                  <c:v>6212.0280541983857</c:v>
                </c:pt>
                <c:pt idx="5">
                  <c:v>6236.5430728301735</c:v>
                </c:pt>
                <c:pt idx="6">
                  <c:v>8542.907706898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DF2-4E34-A7FC-9683FAC0C143}"/>
            </c:ext>
          </c:extLst>
        </c:ser>
        <c:ser>
          <c:idx val="5"/>
          <c:order val="5"/>
          <c:tx>
            <c:strRef>
              <c:f>Expt3_3GNF!$S$271</c:f>
              <c:strCache>
                <c:ptCount val="1"/>
                <c:pt idx="0">
                  <c:v>27 DP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5:$Z$285</c:f>
                <c:numCache>
                  <c:formatCode>General</c:formatCode>
                  <c:ptCount val="7"/>
                  <c:pt idx="0">
                    <c:v>4449.471185912902</c:v>
                  </c:pt>
                  <c:pt idx="1">
                    <c:v>2926.6346661121197</c:v>
                  </c:pt>
                  <c:pt idx="2">
                    <c:v>10245.795945882513</c:v>
                  </c:pt>
                  <c:pt idx="3">
                    <c:v>1039.3360364449609</c:v>
                  </c:pt>
                  <c:pt idx="4">
                    <c:v>974.17434459986134</c:v>
                  </c:pt>
                  <c:pt idx="5">
                    <c:v>471.24571584391833</c:v>
                  </c:pt>
                  <c:pt idx="6">
                    <c:v>4524.5257529020928</c:v>
                  </c:pt>
                </c:numCache>
              </c:numRef>
            </c:plus>
            <c:minus>
              <c:numRef>
                <c:f>Expt3_3GNF!$T$285:$Z$285</c:f>
                <c:numCache>
                  <c:formatCode>General</c:formatCode>
                  <c:ptCount val="7"/>
                  <c:pt idx="0">
                    <c:v>4449.471185912902</c:v>
                  </c:pt>
                  <c:pt idx="1">
                    <c:v>2926.6346661121197</c:v>
                  </c:pt>
                  <c:pt idx="2">
                    <c:v>10245.795945882513</c:v>
                  </c:pt>
                  <c:pt idx="3">
                    <c:v>1039.3360364449609</c:v>
                  </c:pt>
                  <c:pt idx="4">
                    <c:v>974.17434459986134</c:v>
                  </c:pt>
                  <c:pt idx="5">
                    <c:v>471.24571584391833</c:v>
                  </c:pt>
                  <c:pt idx="6">
                    <c:v>4524.52575290209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1:$Z$271</c:f>
              <c:numCache>
                <c:formatCode>General</c:formatCode>
                <c:ptCount val="7"/>
                <c:pt idx="0">
                  <c:v>20531.903969214483</c:v>
                </c:pt>
                <c:pt idx="1">
                  <c:v>18339.016629256443</c:v>
                </c:pt>
                <c:pt idx="2">
                  <c:v>29331.601920280315</c:v>
                </c:pt>
                <c:pt idx="3">
                  <c:v>6751.2967997931</c:v>
                </c:pt>
                <c:pt idx="4">
                  <c:v>4618.0048990342111</c:v>
                </c:pt>
                <c:pt idx="5">
                  <c:v>2831.9571218213314</c:v>
                </c:pt>
                <c:pt idx="6">
                  <c:v>10120.4265163469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DF2-4E34-A7FC-9683FAC0C143}"/>
            </c:ext>
          </c:extLst>
        </c:ser>
        <c:ser>
          <c:idx val="6"/>
          <c:order val="6"/>
          <c:tx>
            <c:strRef>
              <c:f>Expt3_3GNF!$S$272</c:f>
              <c:strCache>
                <c:ptCount val="1"/>
                <c:pt idx="0">
                  <c:v>30 DPA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6:$Z$286</c:f>
                <c:numCache>
                  <c:formatCode>General</c:formatCode>
                  <c:ptCount val="7"/>
                  <c:pt idx="0">
                    <c:v>5012.4469792488899</c:v>
                  </c:pt>
                  <c:pt idx="1">
                    <c:v>262.08827458616554</c:v>
                  </c:pt>
                  <c:pt idx="2">
                    <c:v>1166.0890159518879</c:v>
                  </c:pt>
                  <c:pt idx="3">
                    <c:v>864.68810681347179</c:v>
                  </c:pt>
                  <c:pt idx="4">
                    <c:v>113.74989674697551</c:v>
                  </c:pt>
                  <c:pt idx="5">
                    <c:v>204.40526346287854</c:v>
                  </c:pt>
                  <c:pt idx="6">
                    <c:v>1379.3382555177027</c:v>
                  </c:pt>
                </c:numCache>
              </c:numRef>
            </c:plus>
            <c:minus>
              <c:numRef>
                <c:f>Expt3_3GNF!$T$286:$Z$286</c:f>
                <c:numCache>
                  <c:formatCode>General</c:formatCode>
                  <c:ptCount val="7"/>
                  <c:pt idx="0">
                    <c:v>5012.4469792488899</c:v>
                  </c:pt>
                  <c:pt idx="1">
                    <c:v>262.08827458616554</c:v>
                  </c:pt>
                  <c:pt idx="2">
                    <c:v>1166.0890159518879</c:v>
                  </c:pt>
                  <c:pt idx="3">
                    <c:v>864.68810681347179</c:v>
                  </c:pt>
                  <c:pt idx="4">
                    <c:v>113.74989674697551</c:v>
                  </c:pt>
                  <c:pt idx="5">
                    <c:v>204.40526346287854</c:v>
                  </c:pt>
                  <c:pt idx="6">
                    <c:v>1379.33825551770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2:$Z$272</c:f>
              <c:numCache>
                <c:formatCode>General</c:formatCode>
                <c:ptCount val="7"/>
                <c:pt idx="0">
                  <c:v>28428.267382339294</c:v>
                </c:pt>
                <c:pt idx="1">
                  <c:v>5246.0852996250869</c:v>
                </c:pt>
                <c:pt idx="2">
                  <c:v>5318.3494325928668</c:v>
                </c:pt>
                <c:pt idx="3">
                  <c:v>6200.1068678932888</c:v>
                </c:pt>
                <c:pt idx="4">
                  <c:v>1882.4116826688908</c:v>
                </c:pt>
                <c:pt idx="5">
                  <c:v>5149.3671712153528</c:v>
                </c:pt>
                <c:pt idx="6">
                  <c:v>7329.15984494874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DF2-4E34-A7FC-9683FAC0C143}"/>
            </c:ext>
          </c:extLst>
        </c:ser>
        <c:ser>
          <c:idx val="7"/>
          <c:order val="7"/>
          <c:tx>
            <c:strRef>
              <c:f>Expt3_3GNF!$S$273</c:f>
              <c:strCache>
                <c:ptCount val="1"/>
                <c:pt idx="0">
                  <c:v>35 DP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7:$Z$287</c:f>
                <c:numCache>
                  <c:formatCode>General</c:formatCode>
                  <c:ptCount val="7"/>
                  <c:pt idx="0">
                    <c:v>1242.8873385848574</c:v>
                  </c:pt>
                  <c:pt idx="1">
                    <c:v>898.91171603059126</c:v>
                  </c:pt>
                  <c:pt idx="2">
                    <c:v>662.09434424627955</c:v>
                  </c:pt>
                  <c:pt idx="3">
                    <c:v>632.68213753360533</c:v>
                  </c:pt>
                  <c:pt idx="4">
                    <c:v>1413.5616057182092</c:v>
                  </c:pt>
                  <c:pt idx="5">
                    <c:v>818.15139164919515</c:v>
                  </c:pt>
                  <c:pt idx="6">
                    <c:v>1731.1555448427323</c:v>
                  </c:pt>
                </c:numCache>
              </c:numRef>
            </c:plus>
            <c:minus>
              <c:numRef>
                <c:f>Expt3_3GNF!$T$287:$Z$287</c:f>
                <c:numCache>
                  <c:formatCode>General</c:formatCode>
                  <c:ptCount val="7"/>
                  <c:pt idx="0">
                    <c:v>1242.8873385848574</c:v>
                  </c:pt>
                  <c:pt idx="1">
                    <c:v>898.91171603059126</c:v>
                  </c:pt>
                  <c:pt idx="2">
                    <c:v>662.09434424627955</c:v>
                  </c:pt>
                  <c:pt idx="3">
                    <c:v>632.68213753360533</c:v>
                  </c:pt>
                  <c:pt idx="4">
                    <c:v>1413.5616057182092</c:v>
                  </c:pt>
                  <c:pt idx="5">
                    <c:v>818.15139164919515</c:v>
                  </c:pt>
                  <c:pt idx="6">
                    <c:v>1731.15554484273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3:$Z$273</c:f>
              <c:numCache>
                <c:formatCode>General</c:formatCode>
                <c:ptCount val="7"/>
                <c:pt idx="0">
                  <c:v>5306.9392258781691</c:v>
                </c:pt>
                <c:pt idx="1">
                  <c:v>3389.5772631381756</c:v>
                </c:pt>
                <c:pt idx="2">
                  <c:v>1542.2460154719847</c:v>
                </c:pt>
                <c:pt idx="3">
                  <c:v>4523.6071258386264</c:v>
                </c:pt>
                <c:pt idx="4">
                  <c:v>4785.3397421655854</c:v>
                </c:pt>
                <c:pt idx="5">
                  <c:v>4608.0398717454309</c:v>
                </c:pt>
                <c:pt idx="6">
                  <c:v>5973.1769866128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DF2-4E34-A7FC-9683FAC0C143}"/>
            </c:ext>
          </c:extLst>
        </c:ser>
        <c:ser>
          <c:idx val="8"/>
          <c:order val="8"/>
          <c:tx>
            <c:strRef>
              <c:f>Expt3_3GNF!$S$274</c:f>
              <c:strCache>
                <c:ptCount val="1"/>
                <c:pt idx="0">
                  <c:v>27 DPA+3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8:$Z$288</c:f>
                <c:numCache>
                  <c:formatCode>General</c:formatCode>
                  <c:ptCount val="7"/>
                  <c:pt idx="0">
                    <c:v>4218.0812388862114</c:v>
                  </c:pt>
                  <c:pt idx="1">
                    <c:v>2204.9272108669916</c:v>
                  </c:pt>
                  <c:pt idx="2">
                    <c:v>4200.3338477851412</c:v>
                  </c:pt>
                  <c:pt idx="3">
                    <c:v>67.685475798784836</c:v>
                  </c:pt>
                  <c:pt idx="4">
                    <c:v>1336.5198835837507</c:v>
                  </c:pt>
                  <c:pt idx="5">
                    <c:v>357.23521064481918</c:v>
                  </c:pt>
                  <c:pt idx="6">
                    <c:v>523.84911445510818</c:v>
                  </c:pt>
                </c:numCache>
              </c:numRef>
            </c:plus>
            <c:minus>
              <c:numRef>
                <c:f>Expt3_3GNF!$T$288:$Z$288</c:f>
                <c:numCache>
                  <c:formatCode>General</c:formatCode>
                  <c:ptCount val="7"/>
                  <c:pt idx="0">
                    <c:v>4218.0812388862114</c:v>
                  </c:pt>
                  <c:pt idx="1">
                    <c:v>2204.9272108669916</c:v>
                  </c:pt>
                  <c:pt idx="2">
                    <c:v>4200.3338477851412</c:v>
                  </c:pt>
                  <c:pt idx="3">
                    <c:v>67.685475798784836</c:v>
                  </c:pt>
                  <c:pt idx="4">
                    <c:v>1336.5198835837507</c:v>
                  </c:pt>
                  <c:pt idx="5">
                    <c:v>357.23521064481918</c:v>
                  </c:pt>
                  <c:pt idx="6">
                    <c:v>523.849114455108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4:$Z$274</c:f>
              <c:numCache>
                <c:formatCode>General</c:formatCode>
                <c:ptCount val="7"/>
                <c:pt idx="0">
                  <c:v>16443.10874801052</c:v>
                </c:pt>
                <c:pt idx="1">
                  <c:v>5456.6294604210616</c:v>
                </c:pt>
                <c:pt idx="2">
                  <c:v>19478.293636282848</c:v>
                </c:pt>
                <c:pt idx="3">
                  <c:v>2135.2499176864753</c:v>
                </c:pt>
                <c:pt idx="4">
                  <c:v>5566.5267315633691</c:v>
                </c:pt>
                <c:pt idx="5">
                  <c:v>2838.3142200846373</c:v>
                </c:pt>
                <c:pt idx="6">
                  <c:v>3388.168164638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DF2-4E34-A7FC-9683FAC0C143}"/>
            </c:ext>
          </c:extLst>
        </c:ser>
        <c:ser>
          <c:idx val="9"/>
          <c:order val="9"/>
          <c:tx>
            <c:strRef>
              <c:f>Expt3_3GNF!$S$275</c:f>
              <c:strCache>
                <c:ptCount val="1"/>
                <c:pt idx="0">
                  <c:v>27 DPA+3 cool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Expt3_3GNF!$T$289:$Z$289</c:f>
                <c:numCache>
                  <c:formatCode>General</c:formatCode>
                  <c:ptCount val="7"/>
                  <c:pt idx="0">
                    <c:v>4286.595945101024</c:v>
                  </c:pt>
                  <c:pt idx="1">
                    <c:v>545.6164572752989</c:v>
                  </c:pt>
                  <c:pt idx="2">
                    <c:v>2704.7810912255604</c:v>
                  </c:pt>
                  <c:pt idx="3">
                    <c:v>856.93196664435959</c:v>
                  </c:pt>
                  <c:pt idx="4">
                    <c:v>2375.354612388935</c:v>
                  </c:pt>
                  <c:pt idx="5">
                    <c:v>2133.8928157318828</c:v>
                  </c:pt>
                  <c:pt idx="6">
                    <c:v>1516.5662916249628</c:v>
                  </c:pt>
                </c:numCache>
              </c:numRef>
            </c:plus>
            <c:minus>
              <c:numRef>
                <c:f>Expt3_3GNF!$T$289:$Z$289</c:f>
                <c:numCache>
                  <c:formatCode>General</c:formatCode>
                  <c:ptCount val="7"/>
                  <c:pt idx="0">
                    <c:v>4286.595945101024</c:v>
                  </c:pt>
                  <c:pt idx="1">
                    <c:v>545.6164572752989</c:v>
                  </c:pt>
                  <c:pt idx="2">
                    <c:v>2704.7810912255604</c:v>
                  </c:pt>
                  <c:pt idx="3">
                    <c:v>856.93196664435959</c:v>
                  </c:pt>
                  <c:pt idx="4">
                    <c:v>2375.354612388935</c:v>
                  </c:pt>
                  <c:pt idx="5">
                    <c:v>2133.8928157318828</c:v>
                  </c:pt>
                  <c:pt idx="6">
                    <c:v>1516.56629162496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xpt3_3GNF!$T$265:$Z$265</c:f>
              <c:strCache>
                <c:ptCount val="7"/>
                <c:pt idx="0">
                  <c:v>Hartog</c:v>
                </c:pt>
                <c:pt idx="1">
                  <c:v>RAC655</c:v>
                </c:pt>
                <c:pt idx="2">
                  <c:v>Kennedy</c:v>
                </c:pt>
                <c:pt idx="3">
                  <c:v>Nainari Rht</c:v>
                </c:pt>
                <c:pt idx="4">
                  <c:v>Nainari rht</c:v>
                </c:pt>
                <c:pt idx="5">
                  <c:v>Maringa Rht</c:v>
                </c:pt>
                <c:pt idx="6">
                  <c:v>Maringa rht</c:v>
                </c:pt>
              </c:strCache>
            </c:strRef>
          </c:cat>
          <c:val>
            <c:numRef>
              <c:f>Expt3_3GNF!$T$275:$Z$275</c:f>
              <c:numCache>
                <c:formatCode>General</c:formatCode>
                <c:ptCount val="7"/>
                <c:pt idx="0">
                  <c:v>11515.876128728296</c:v>
                </c:pt>
                <c:pt idx="1">
                  <c:v>16332.788586151199</c:v>
                </c:pt>
                <c:pt idx="2">
                  <c:v>14054.490849473519</c:v>
                </c:pt>
                <c:pt idx="3">
                  <c:v>3836.1998240395237</c:v>
                </c:pt>
                <c:pt idx="4">
                  <c:v>10623.513529638441</c:v>
                </c:pt>
                <c:pt idx="5">
                  <c:v>6575.9910137816451</c:v>
                </c:pt>
                <c:pt idx="6">
                  <c:v>6846.26114126825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DF2-4E34-A7FC-9683FAC0C1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8154024"/>
        <c:axId val="808147464"/>
      </c:barChart>
      <c:catAx>
        <c:axId val="8081540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2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riety</a:t>
                </a:r>
                <a:endParaRPr lang="en-AU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4514604000879976"/>
              <c:y val="0.845602631880479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08147464"/>
        <c:crosses val="autoZero"/>
        <c:auto val="1"/>
        <c:lblAlgn val="ctr"/>
        <c:lblOffset val="100"/>
        <c:noMultiLvlLbl val="0"/>
      </c:catAx>
      <c:valAx>
        <c:axId val="8081474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12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nscript abundance</a:t>
                </a:r>
                <a:endParaRPr lang="en-AU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08154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1974564637906783E-2"/>
          <c:y val="0.92315460031770191"/>
          <c:w val="0.89999989633089872"/>
          <c:h val="4.652088614436725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32D4C1-ECBE-4637-9D31-39B95190E476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D73D0E-081F-44DA-875E-7F7D9B86A5E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23868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1600" i="1" dirty="0" err="1" smtClean="0"/>
              <a:t>LMA1</a:t>
            </a:r>
            <a:r>
              <a:rPr lang="en-AU" sz="1600" dirty="0" smtClean="0"/>
              <a:t> transcript abundance in developing grain of wheat varieties sampled at 10, 15, 18, 21, 24, 27, 30 and 35 days after </a:t>
            </a:r>
            <a:r>
              <a:rPr lang="en-AU" sz="1600" dirty="0" err="1" smtClean="0"/>
              <a:t>anthesis</a:t>
            </a:r>
            <a:r>
              <a:rPr lang="en-AU" sz="1600" dirty="0" smtClean="0"/>
              <a:t> (</a:t>
            </a:r>
            <a:r>
              <a:rPr lang="en-AU" sz="1600" dirty="0" err="1" smtClean="0"/>
              <a:t>dpa</a:t>
            </a:r>
            <a:r>
              <a:rPr lang="en-AU" sz="1600" dirty="0" smtClean="0"/>
              <a:t>) and at 27 </a:t>
            </a:r>
            <a:r>
              <a:rPr lang="en-AU" sz="1600" dirty="0" err="1" smtClean="0"/>
              <a:t>dpa</a:t>
            </a:r>
            <a:r>
              <a:rPr lang="en-AU" sz="1600" dirty="0" smtClean="0"/>
              <a:t> plus 3 day control or 3 day cool shock. Error bars indicate </a:t>
            </a:r>
            <a:r>
              <a:rPr lang="en-AU" sz="1600" dirty="0" err="1" smtClean="0"/>
              <a:t>SEM</a:t>
            </a:r>
            <a:r>
              <a:rPr lang="en-AU" sz="1600" dirty="0" smtClean="0"/>
              <a:t> from 3 biological replicates. </a:t>
            </a:r>
            <a:r>
              <a:rPr lang="en-AU" sz="1600" dirty="0" err="1" smtClean="0"/>
              <a:t>Nainari</a:t>
            </a:r>
            <a:r>
              <a:rPr lang="en-AU" sz="1600" dirty="0" smtClean="0"/>
              <a:t> </a:t>
            </a:r>
            <a:r>
              <a:rPr lang="en-AU" sz="1600" dirty="0" err="1" smtClean="0"/>
              <a:t>rht</a:t>
            </a:r>
            <a:r>
              <a:rPr lang="en-AU" sz="1600" dirty="0" smtClean="0"/>
              <a:t> and </a:t>
            </a:r>
            <a:r>
              <a:rPr lang="en-AU" sz="1600" dirty="0" err="1" smtClean="0"/>
              <a:t>Nainari</a:t>
            </a:r>
            <a:r>
              <a:rPr lang="en-AU" sz="1600" dirty="0" smtClean="0"/>
              <a:t> </a:t>
            </a:r>
            <a:r>
              <a:rPr lang="en-AU" sz="1600" dirty="0" err="1" smtClean="0"/>
              <a:t>Rht</a:t>
            </a:r>
            <a:r>
              <a:rPr lang="en-AU" sz="1600" dirty="0" smtClean="0"/>
              <a:t> refer to tall (</a:t>
            </a:r>
            <a:r>
              <a:rPr lang="en-AU" sz="1600" i="1" dirty="0" err="1" smtClean="0"/>
              <a:t>Rht-D1a</a:t>
            </a:r>
            <a:r>
              <a:rPr lang="en-AU" sz="1600" dirty="0" smtClean="0"/>
              <a:t>) and semi-dwarf (</a:t>
            </a:r>
            <a:r>
              <a:rPr lang="en-AU" sz="1600" i="1" dirty="0" err="1" smtClean="0"/>
              <a:t>Rht-D1b</a:t>
            </a:r>
            <a:r>
              <a:rPr lang="en-AU" sz="1600" dirty="0" smtClean="0"/>
              <a:t>) near-isogenic lines. Similarly for Maringa </a:t>
            </a:r>
            <a:r>
              <a:rPr lang="en-AU" sz="1600" dirty="0" err="1" smtClean="0"/>
              <a:t>rht</a:t>
            </a:r>
            <a:r>
              <a:rPr lang="en-AU" sz="1600" dirty="0" smtClean="0"/>
              <a:t> and Maringa </a:t>
            </a:r>
            <a:r>
              <a:rPr lang="en-AU" sz="1600" dirty="0" err="1" smtClean="0"/>
              <a:t>Rht</a:t>
            </a:r>
            <a:r>
              <a:rPr lang="en-AU" sz="1600" dirty="0" smtClean="0"/>
              <a:t>.</a:t>
            </a:r>
          </a:p>
          <a:p>
            <a:endParaRPr lang="en-AU" sz="16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A3854B-4E14-43D7-A743-F4426A591E9C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73049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9028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5614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83093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58319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3912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9652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95699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6217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45482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9978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3496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4B36B-2082-4FBD-95FC-0D7FFED251D8}" type="datetimeFigureOut">
              <a:rPr lang="en-AU" smtClean="0"/>
              <a:t>29/01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EF8E5-F6B5-45AE-984F-63158013E6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2196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742659" y="364767"/>
          <a:ext cx="10063886" cy="49570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998373" y="5512452"/>
            <a:ext cx="9986302" cy="1231106"/>
            <a:chOff x="867746" y="182879"/>
            <a:chExt cx="10749290" cy="1231106"/>
          </a:xfrm>
        </p:grpSpPr>
        <p:sp>
          <p:nvSpPr>
            <p:cNvPr id="2" name="TextBox 1"/>
            <p:cNvSpPr txBox="1"/>
            <p:nvPr/>
          </p:nvSpPr>
          <p:spPr>
            <a:xfrm>
              <a:off x="867746" y="182879"/>
              <a:ext cx="33030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AU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8</a:t>
              </a:r>
              <a:endParaRPr lang="en-AU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867746" y="552211"/>
              <a:ext cx="10749290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MA1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anscript abundance in developing grain of 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eat 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rieties sampled at 10, 15, 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, 21, 24, 27, 30 and 35 days 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ter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hesis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pa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27 </a:t>
              </a:r>
              <a:r>
                <a:rPr lang="en-AU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pa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lus 3 day control or 3 day cool shock. Error bars indicate </a:t>
              </a:r>
              <a:r>
                <a:rPr lang="en-AU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M</a:t>
              </a:r>
              <a:r>
                <a:rPr lang="en-AU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 3 biological replicates. </a:t>
              </a:r>
            </a:p>
            <a:p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inari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ainari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fer to tall (</a:t>
              </a:r>
              <a:r>
                <a:rPr lang="en-AU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-D1a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semi-dwarf (</a:t>
              </a:r>
              <a:r>
                <a:rPr lang="en-AU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-D1b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near-isogenic lines. Similarly for Maringa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Maringa </a:t>
              </a:r>
              <a:r>
                <a:rPr lang="en-AU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t</a:t>
              </a:r>
              <a:r>
                <a:rPr lang="en-AU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  <a:p>
              <a:endParaRPr lang="en-AU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15524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yl Mares</dc:creator>
  <cp:lastModifiedBy>Daryl Mares</cp:lastModifiedBy>
  <cp:revision>1</cp:revision>
  <dcterms:created xsi:type="dcterms:W3CDTF">2021-01-28T22:06:23Z</dcterms:created>
  <dcterms:modified xsi:type="dcterms:W3CDTF">2021-01-28T22:06:55Z</dcterms:modified>
</cp:coreProperties>
</file>